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1332071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1476" y="-5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80034"/>
            <a:ext cx="10363200" cy="463758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996459"/>
            <a:ext cx="9144000" cy="321608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210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294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09204"/>
            <a:ext cx="2628900" cy="1128868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09204"/>
            <a:ext cx="7734300" cy="1128868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6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499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320931"/>
            <a:ext cx="10515600" cy="5541046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914398"/>
            <a:ext cx="10515600" cy="291390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744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546023"/>
            <a:ext cx="5181600" cy="845187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546023"/>
            <a:ext cx="5181600" cy="845187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01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09208"/>
            <a:ext cx="10515600" cy="257472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265426"/>
            <a:ext cx="5157787" cy="160033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865760"/>
            <a:ext cx="5157787" cy="715680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265426"/>
            <a:ext cx="5183188" cy="160033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865760"/>
            <a:ext cx="5183188" cy="715680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49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781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7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88048"/>
            <a:ext cx="3932237" cy="3108166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17939"/>
            <a:ext cx="6172200" cy="946634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996214"/>
            <a:ext cx="3932237" cy="74034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41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88048"/>
            <a:ext cx="3932237" cy="3108166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17939"/>
            <a:ext cx="6172200" cy="946634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996214"/>
            <a:ext cx="3932237" cy="74034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908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09208"/>
            <a:ext cx="10515600" cy="2574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546023"/>
            <a:ext cx="10515600" cy="84518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346330"/>
            <a:ext cx="27432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22619-1BA2-46D7-8E7C-6DFC3420346C}" type="datetimeFigureOut">
              <a:rPr lang="en-US" smtClean="0"/>
              <a:t>7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346330"/>
            <a:ext cx="41148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346330"/>
            <a:ext cx="27432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856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27" b="8195"/>
          <a:stretch/>
        </p:blipFill>
        <p:spPr>
          <a:xfrm>
            <a:off x="423682" y="54881"/>
            <a:ext cx="11390170" cy="322159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74" b="6985"/>
          <a:stretch/>
        </p:blipFill>
        <p:spPr>
          <a:xfrm>
            <a:off x="423682" y="3414315"/>
            <a:ext cx="11390170" cy="3108838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0" y="-26894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170" y="3180077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98" y="6531730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74" b="7830"/>
          <a:stretch/>
        </p:blipFill>
        <p:spPr>
          <a:xfrm>
            <a:off x="423683" y="6695327"/>
            <a:ext cx="11390170" cy="3204298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195" b="9172"/>
          <a:stretch/>
        </p:blipFill>
        <p:spPr>
          <a:xfrm>
            <a:off x="383852" y="10038258"/>
            <a:ext cx="11430000" cy="320429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3007894" y="10128333"/>
            <a:ext cx="7784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SREBF2 acros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 (with tumor vs. normal samples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007895" y="6565102"/>
            <a:ext cx="7784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MVD acros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 (with tumor vs. normal samples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007894" y="3368627"/>
            <a:ext cx="7784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HMGCS1 acros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 (with tumor vs. normal samples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007894" y="96383"/>
            <a:ext cx="7784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MSMO1 acros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s (with tumor vs. normal samples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4138" y="9942006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2032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00</TotalTime>
  <Words>60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16</cp:revision>
  <dcterms:created xsi:type="dcterms:W3CDTF">2022-06-23T08:05:18Z</dcterms:created>
  <dcterms:modified xsi:type="dcterms:W3CDTF">2023-07-12T05:12:52Z</dcterms:modified>
</cp:coreProperties>
</file>